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A417A-524C-8A4A-BDD3-92C9CE8BC6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7AE8A5-3E0A-9476-21F8-47B3CC7C93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4386F1-CA6E-FCFA-83E9-6666EEAF9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4DC4D-CFFF-3478-36F7-87D1FFFDF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888FE-750C-B515-7BD6-84B0E9DA5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783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22A6A9-0472-AD92-F1C8-F2C5FBCD7C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B84EE5-41AF-94E1-F80B-A23D34320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576861-812E-7FE8-DFA6-CE91F1543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BA65CA-1DA6-BC45-AAB1-FD08B9AAE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648F6D-3286-479B-606B-6796BACCF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0104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C1C00D-FBB0-E886-6E28-8EDE196FF3C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FAC146-66DE-7585-EB00-DF99D2B357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1D5FB7-276E-9196-8769-A40B2E852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3B7C70-A324-90E6-E8C7-60F4C2E0D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3A4844-8CD3-FCE8-D5E8-DF75A41531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46463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6EB3D-7AE3-A333-DCA9-1152014586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ED433D-3DA5-FFF1-CD2D-2B7619FA94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D217C7-9383-A808-7B6A-5966E9D43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13C498-C4D8-0F43-783E-4743C1FD3D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5D8004-0FD5-9AE1-7F33-B681B49B9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1858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B6B64A-864F-2141-041D-574B9415E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8C0BBE-D656-2B02-545E-4325F7D0C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24C9F2-B2ED-BE97-6C01-6B09234E3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AA1F1D-4373-8FF2-5E88-8878BFAC06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4025A4-7A0E-38C0-F51C-595BB3F89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949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4FBAA-E7D4-5697-CA88-B7891F0C4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388E4D-BACC-E948-904E-424EA5594C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979F9D-6BCD-681D-CCEE-DD4717267C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1A9CAE-59EE-CE67-2430-E37F5733E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551B08-D1B2-46BC-D50C-FD430E778D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8E6F9B-6C4E-8750-4F5B-AAE169141C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09833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4EF748-308B-0FC3-9A8B-A84406326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7CD4FF-C438-C07B-E576-EF51768254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D46106-7CC8-7086-FA62-60502B6478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E133BF-DF65-182F-2788-F3E4566E32C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1E0A76B-A829-02EC-8D71-AFFF143999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22EF45-0DCF-8E8D-5948-ACD952163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820C976-CE19-66D4-9551-729FC4449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C3CD87F-9F39-9FA6-2BFF-F6626E251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328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077E43-B5B6-B514-8AB4-B1596D2220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12743D-4A92-F1E5-14D8-37DB17E233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3B82E3D-85E7-C586-9081-C65D0D274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CA7FFD-719E-3280-4D24-7616A5085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4360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F3657E-A8BF-F9B8-3593-A5BA15143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22759A6-17B0-6681-F316-6E1ADDD26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76E18F-D6F3-BB1D-92FB-4499D18BEF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0120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5FF0F4-3F7F-8DAF-5435-E59EF09B7A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7ADF01-77DA-7C00-1CF7-BD2517B1F6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8208A7-6C6B-32E1-F160-2CD0A54ED0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3871F2-B9DD-FCBC-D687-BDC2375C4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A08F6A-522D-7200-C0BB-E06CE33637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464DE6-0B8B-3CA5-CE8E-B07F093F3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65784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3207F7-6D85-D931-05B6-8BF094FF9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F76473-4BC5-2251-4363-10D9FF0D36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AEB7CA0-9DC2-9F85-2982-E2C41AD66A2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AD8BA0-27D2-56E8-7F64-AFF37F076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DF50D3-CD9B-672B-9855-40A0D1039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8E7C47-5C33-F50E-0C7E-5591DFF4B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74615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BA375B-6B63-8170-F118-4A2D1BF76E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AE06BE-EE09-B7B1-4728-56C8B35BFA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4D86CD-8B88-4B18-C9C9-82DB738CC7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92128-2A6E-4960-B404-E90E89ECDA6D}" type="datetimeFigureOut">
              <a:rPr lang="fr-FR" smtClean="0"/>
              <a:t>02/11/2024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0F8DCE-AC60-EA45-A9D1-67CD940C90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461686-4237-32F2-A095-06326584728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DFD1BE-1148-483B-96AF-E68B4E96921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9682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4AF5EE2C-CC85-ACCC-4437-A53C9F719A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767" y="5745621"/>
            <a:ext cx="11041484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. </a:t>
            </a:r>
            <a:r>
              <a:rPr kumimoji="0" lang="en-US" altLang="fr-FR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atment interaction plot for OS with continuous STC1 in patients with mCRC treated with regorafenib in the CORRECT trial.</a:t>
            </a:r>
            <a:endParaRPr kumimoji="0" lang="fr-FR" altLang="fr-F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altLang="fr-F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5" name="Picture 1">
            <a:extLst>
              <a:ext uri="{FF2B5EF4-FFF2-40B4-BE49-F238E27FC236}">
                <a16:creationId xmlns:a16="http://schemas.microsoft.com/office/drawing/2014/main" id="{93B0908A-EB80-6948-F4CA-D1DDD55DCD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4021" y="699337"/>
            <a:ext cx="6843860" cy="4887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CFF19E4B-4156-4F1B-B4BC-622DDC1C4A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4597" y="6150058"/>
            <a:ext cx="800732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fr-FR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I, confidence interval; HR, hazard ratio; mCRC, metastatic colorectal cancer; OS, overall survival.</a:t>
            </a:r>
            <a:endParaRPr kumimoji="0" lang="en-GB" altLang="fr-FR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98804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ophe Borg</dc:creator>
  <cp:lastModifiedBy>Christophe Borg</cp:lastModifiedBy>
  <cp:revision>1</cp:revision>
  <dcterms:created xsi:type="dcterms:W3CDTF">2024-11-02T17:45:14Z</dcterms:created>
  <dcterms:modified xsi:type="dcterms:W3CDTF">2024-11-02T17:46:30Z</dcterms:modified>
</cp:coreProperties>
</file>